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6985" autoAdjust="0"/>
    <p:restoredTop sz="94249" autoAdjust="0"/>
  </p:normalViewPr>
  <p:slideViewPr>
    <p:cSldViewPr snapToGrid="0">
      <p:cViewPr varScale="1">
        <p:scale>
          <a:sx n="105" d="100"/>
          <a:sy n="105" d="100"/>
        </p:scale>
        <p:origin x="1122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Factor%20B\Steady%20State%20Conditions%20F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atologia!$A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3E0-45AE-B3B6-A1477D04B61B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3E0-45AE-B3B6-A1477D04B61B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3E0-45AE-B3B6-A1477D04B61B}"/>
              </c:ext>
            </c:extLst>
          </c:dPt>
          <c:errBars>
            <c:errBarType val="plus"/>
            <c:errValType val="cust"/>
            <c:noEndCap val="0"/>
            <c:plus>
              <c:numRef>
                <c:f>Hematologia!$D$9:$I$9</c:f>
                <c:numCache>
                  <c:formatCode>General</c:formatCode>
                  <c:ptCount val="6"/>
                  <c:pt idx="0">
                    <c:v>0.63287702860297856</c:v>
                  </c:pt>
                  <c:pt idx="1">
                    <c:v>0.45574115460423364</c:v>
                  </c:pt>
                  <c:pt idx="2">
                    <c:v>0.60871449246205189</c:v>
                  </c:pt>
                  <c:pt idx="3">
                    <c:v>0.34151622704248391</c:v>
                  </c:pt>
                  <c:pt idx="4">
                    <c:v>0.18770544300401448</c:v>
                  </c:pt>
                  <c:pt idx="5">
                    <c:v>2.6457513110645911E-2</c:v>
                  </c:pt>
                </c:numCache>
              </c:numRef>
            </c:plus>
            <c:minus>
              <c:numRef>
                <c:f>Hematologia!$D$9:$I$9</c:f>
                <c:numCache>
                  <c:formatCode>General</c:formatCode>
                  <c:ptCount val="6"/>
                  <c:pt idx="0">
                    <c:v>0.63287702860297856</c:v>
                  </c:pt>
                  <c:pt idx="1">
                    <c:v>0.45574115460423364</c:v>
                  </c:pt>
                  <c:pt idx="2">
                    <c:v>0.60871449246205189</c:v>
                  </c:pt>
                  <c:pt idx="3">
                    <c:v>0.34151622704248391</c:v>
                  </c:pt>
                  <c:pt idx="4">
                    <c:v>0.18770544300401448</c:v>
                  </c:pt>
                  <c:pt idx="5">
                    <c:v>2.6457513110645911E-2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D$3:$G$3</c:f>
              <c:strCache>
                <c:ptCount val="4"/>
                <c:pt idx="0">
                  <c:v>WBC</c:v>
                </c:pt>
                <c:pt idx="1">
                  <c:v>NE</c:v>
                </c:pt>
                <c:pt idx="2">
                  <c:v>LY</c:v>
                </c:pt>
                <c:pt idx="3">
                  <c:v>MO</c:v>
                </c:pt>
              </c:strCache>
            </c:strRef>
          </c:cat>
          <c:val>
            <c:numRef>
              <c:f>Hematologia!$D$8:$G$8</c:f>
              <c:numCache>
                <c:formatCode>0.00</c:formatCode>
                <c:ptCount val="4"/>
                <c:pt idx="0">
                  <c:v>5.0266666666666664</c:v>
                </c:pt>
                <c:pt idx="1">
                  <c:v>1.9000000000000001</c:v>
                </c:pt>
                <c:pt idx="2">
                  <c:v>5.0033333333333339</c:v>
                </c:pt>
                <c:pt idx="3">
                  <c:v>0.573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3E0-45AE-B3B6-A1477D04B61B}"/>
            </c:ext>
          </c:extLst>
        </c:ser>
        <c:ser>
          <c:idx val="1"/>
          <c:order val="1"/>
          <c:tx>
            <c:strRef>
              <c:f>Hematologia!$A$10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D$15:$I$15</c:f>
                <c:numCache>
                  <c:formatCode>General</c:formatCode>
                  <c:ptCount val="6"/>
                  <c:pt idx="0">
                    <c:v>0.75055534994651929</c:v>
                  </c:pt>
                  <c:pt idx="1">
                    <c:v>0.30550504633038922</c:v>
                  </c:pt>
                  <c:pt idx="2">
                    <c:v>1.2288205727444499</c:v>
                  </c:pt>
                  <c:pt idx="3">
                    <c:v>0.1154700538379254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Hematologia!$D$15:$I$15</c:f>
                <c:numCache>
                  <c:formatCode>General</c:formatCode>
                  <c:ptCount val="6"/>
                  <c:pt idx="0">
                    <c:v>0.75055534994651929</c:v>
                  </c:pt>
                  <c:pt idx="1">
                    <c:v>0.30550504633038922</c:v>
                  </c:pt>
                  <c:pt idx="2">
                    <c:v>1.2288205727444499</c:v>
                  </c:pt>
                  <c:pt idx="3">
                    <c:v>0.1154700538379254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D$3:$G$3</c:f>
              <c:strCache>
                <c:ptCount val="4"/>
                <c:pt idx="0">
                  <c:v>WBC</c:v>
                </c:pt>
                <c:pt idx="1">
                  <c:v>NE</c:v>
                </c:pt>
                <c:pt idx="2">
                  <c:v>LY</c:v>
                </c:pt>
                <c:pt idx="3">
                  <c:v>MO</c:v>
                </c:pt>
              </c:strCache>
            </c:strRef>
          </c:cat>
          <c:val>
            <c:numRef>
              <c:f>Hematologia!$D$14:$G$14</c:f>
              <c:numCache>
                <c:formatCode>0.00</c:formatCode>
                <c:ptCount val="4"/>
                <c:pt idx="0">
                  <c:v>5.35</c:v>
                </c:pt>
                <c:pt idx="1">
                  <c:v>1.4333333333333333</c:v>
                </c:pt>
                <c:pt idx="2">
                  <c:v>4.7</c:v>
                </c:pt>
                <c:pt idx="3">
                  <c:v>0.3333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3E0-45AE-B3B6-A1477D04B6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b="1" i="0" baseline="0" dirty="0">
                    <a:effectLst/>
                  </a:rPr>
                  <a:t>K/µ</a:t>
                </a:r>
                <a:r>
                  <a:rPr lang="pl-PL" sz="1200" b="1" i="0" baseline="0" dirty="0">
                    <a:effectLst/>
                  </a:rPr>
                  <a:t>l</a:t>
                </a:r>
                <a:endParaRPr lang="pl-PL" sz="1200" dirty="0">
                  <a:effectLst/>
                </a:endParaRP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atologia!$A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A39C-48DB-8496-5240CE532A34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A39C-48DB-8496-5240CE532A34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A39C-48DB-8496-5240CE532A34}"/>
              </c:ext>
            </c:extLst>
          </c:dPt>
          <c:errBars>
            <c:errBarType val="plus"/>
            <c:errValType val="cust"/>
            <c:noEndCap val="0"/>
            <c:plus>
              <c:numRef>
                <c:f>Hematologia!$J$9:$P$9</c:f>
                <c:numCache>
                  <c:formatCode>General</c:formatCode>
                  <c:ptCount val="7"/>
                  <c:pt idx="0">
                    <c:v>0.72380936716790323</c:v>
                  </c:pt>
                  <c:pt idx="1">
                    <c:v>2.1633307652783951</c:v>
                  </c:pt>
                  <c:pt idx="2">
                    <c:v>2.7622454633866256</c:v>
                  </c:pt>
                  <c:pt idx="3">
                    <c:v>0.83266639978645007</c:v>
                  </c:pt>
                  <c:pt idx="4">
                    <c:v>0.42426406871192823</c:v>
                  </c:pt>
                  <c:pt idx="5">
                    <c:v>0.35355339059327379</c:v>
                  </c:pt>
                  <c:pt idx="6">
                    <c:v>2.5059928172283055</c:v>
                  </c:pt>
                </c:numCache>
              </c:numRef>
            </c:plus>
            <c:minus>
              <c:numRef>
                <c:f>Hematologia!$J$9:$P$9</c:f>
                <c:numCache>
                  <c:formatCode>General</c:formatCode>
                  <c:ptCount val="7"/>
                  <c:pt idx="0">
                    <c:v>0.72380936716790323</c:v>
                  </c:pt>
                  <c:pt idx="1">
                    <c:v>2.1633307652783951</c:v>
                  </c:pt>
                  <c:pt idx="2">
                    <c:v>2.7622454633866256</c:v>
                  </c:pt>
                  <c:pt idx="3">
                    <c:v>0.83266639978645007</c:v>
                  </c:pt>
                  <c:pt idx="4">
                    <c:v>0.42426406871192823</c:v>
                  </c:pt>
                  <c:pt idx="5">
                    <c:v>0.35355339059327379</c:v>
                  </c:pt>
                  <c:pt idx="6">
                    <c:v>2.5059928172283055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J$3:$P$3</c:f>
              <c:strCache>
                <c:ptCount val="7"/>
                <c:pt idx="0">
                  <c:v>RBC (M/ul)</c:v>
                </c:pt>
                <c:pt idx="1">
                  <c:v>Hb (g/dl)</c:v>
                </c:pt>
                <c:pt idx="2">
                  <c:v>HCT (%)</c:v>
                </c:pt>
                <c:pt idx="3">
                  <c:v>MCV (fl)</c:v>
                </c:pt>
                <c:pt idx="4">
                  <c:v>MCH (pg)</c:v>
                </c:pt>
                <c:pt idx="5">
                  <c:v>MCHC (g/dl)</c:v>
                </c:pt>
                <c:pt idx="6">
                  <c:v>RDW (%)</c:v>
                </c:pt>
              </c:strCache>
            </c:strRef>
          </c:cat>
          <c:val>
            <c:numRef>
              <c:f>Hematologia!$J$8:$P$8</c:f>
              <c:numCache>
                <c:formatCode>0.00</c:formatCode>
                <c:ptCount val="7"/>
                <c:pt idx="0">
                  <c:v>10.76</c:v>
                </c:pt>
                <c:pt idx="1">
                  <c:v>15.200000000000001</c:v>
                </c:pt>
                <c:pt idx="2">
                  <c:v>50.699999999999996</c:v>
                </c:pt>
                <c:pt idx="3">
                  <c:v>47.866666666666674</c:v>
                </c:pt>
                <c:pt idx="4">
                  <c:v>13.2</c:v>
                </c:pt>
                <c:pt idx="5">
                  <c:v>27.35</c:v>
                </c:pt>
                <c:pt idx="6">
                  <c:v>19.4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39C-48DB-8496-5240CE532A34}"/>
            </c:ext>
          </c:extLst>
        </c:ser>
        <c:ser>
          <c:idx val="1"/>
          <c:order val="1"/>
          <c:tx>
            <c:strRef>
              <c:f>Hematologia!$A$10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J$15:$P$15</c:f>
                <c:numCache>
                  <c:formatCode>General</c:formatCode>
                  <c:ptCount val="7"/>
                  <c:pt idx="0">
                    <c:v>1.1481724609134296</c:v>
                  </c:pt>
                  <c:pt idx="1">
                    <c:v>1.5373136743466933</c:v>
                  </c:pt>
                  <c:pt idx="2">
                    <c:v>4.9084960357866603</c:v>
                  </c:pt>
                  <c:pt idx="3">
                    <c:v>0.9848857801796097</c:v>
                  </c:pt>
                  <c:pt idx="4">
                    <c:v>0.28867513459481292</c:v>
                  </c:pt>
                  <c:pt idx="5">
                    <c:v>0.55075705472860725</c:v>
                  </c:pt>
                  <c:pt idx="6">
                    <c:v>3.9051248379533128</c:v>
                  </c:pt>
                </c:numCache>
              </c:numRef>
            </c:plus>
            <c:minus>
              <c:numRef>
                <c:f>Hematologia!$J$15:$P$15</c:f>
                <c:numCache>
                  <c:formatCode>General</c:formatCode>
                  <c:ptCount val="7"/>
                  <c:pt idx="0">
                    <c:v>1.1481724609134296</c:v>
                  </c:pt>
                  <c:pt idx="1">
                    <c:v>1.5373136743466933</c:v>
                  </c:pt>
                  <c:pt idx="2">
                    <c:v>4.9084960357866603</c:v>
                  </c:pt>
                  <c:pt idx="3">
                    <c:v>0.9848857801796097</c:v>
                  </c:pt>
                  <c:pt idx="4">
                    <c:v>0.28867513459481292</c:v>
                  </c:pt>
                  <c:pt idx="5">
                    <c:v>0.55075705472860725</c:v>
                  </c:pt>
                  <c:pt idx="6">
                    <c:v>3.9051248379533128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J$3:$P$3</c:f>
              <c:strCache>
                <c:ptCount val="7"/>
                <c:pt idx="0">
                  <c:v>RBC (M/ul)</c:v>
                </c:pt>
                <c:pt idx="1">
                  <c:v>Hb (g/dl)</c:v>
                </c:pt>
                <c:pt idx="2">
                  <c:v>HCT (%)</c:v>
                </c:pt>
                <c:pt idx="3">
                  <c:v>MCV (fl)</c:v>
                </c:pt>
                <c:pt idx="4">
                  <c:v>MCH (pg)</c:v>
                </c:pt>
                <c:pt idx="5">
                  <c:v>MCHC (g/dl)</c:v>
                </c:pt>
                <c:pt idx="6">
                  <c:v>RDW (%)</c:v>
                </c:pt>
              </c:strCache>
            </c:strRef>
          </c:cat>
          <c:val>
            <c:numRef>
              <c:f>Hematologia!$J$14:$P$14</c:f>
              <c:numCache>
                <c:formatCode>0.00</c:formatCode>
                <c:ptCount val="7"/>
                <c:pt idx="0">
                  <c:v>10.700000000000001</c:v>
                </c:pt>
                <c:pt idx="1">
                  <c:v>16.133333333333333</c:v>
                </c:pt>
                <c:pt idx="2">
                  <c:v>44.533333333333339</c:v>
                </c:pt>
                <c:pt idx="3">
                  <c:v>41.6</c:v>
                </c:pt>
                <c:pt idx="4">
                  <c:v>15.066666666666668</c:v>
                </c:pt>
                <c:pt idx="5">
                  <c:v>36.233333333333334</c:v>
                </c:pt>
                <c:pt idx="6">
                  <c:v>21.6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39C-48DB-8496-5240CE532A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ematologia!$A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D9A-4039-AEAD-F33A8ABF5048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DD9A-4039-AEAD-F33A8ABF5048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DD9A-4039-AEAD-F33A8ABF5048}"/>
              </c:ext>
            </c:extLst>
          </c:dPt>
          <c:errBars>
            <c:errBarType val="plus"/>
            <c:errValType val="cust"/>
            <c:noEndCap val="0"/>
            <c:plus>
              <c:numRef>
                <c:f>Hematologia!$Q$9</c:f>
                <c:numCache>
                  <c:formatCode>General</c:formatCode>
                  <c:ptCount val="1"/>
                  <c:pt idx="0">
                    <c:v>107.59801732993677</c:v>
                  </c:pt>
                </c:numCache>
              </c:numRef>
            </c:plus>
            <c:minus>
              <c:numRef>
                <c:f>Hematologia!$Q$9</c:f>
                <c:numCache>
                  <c:formatCode>General</c:formatCode>
                  <c:ptCount val="1"/>
                  <c:pt idx="0">
                    <c:v>107.59801732993677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Q$3</c:f>
              <c:strCache>
                <c:ptCount val="1"/>
                <c:pt idx="0">
                  <c:v>PLT</c:v>
                </c:pt>
              </c:strCache>
            </c:strRef>
          </c:cat>
          <c:val>
            <c:numRef>
              <c:f>Hematologia!$Q$8</c:f>
              <c:numCache>
                <c:formatCode>0.00</c:formatCode>
                <c:ptCount val="1"/>
                <c:pt idx="0">
                  <c:v>639.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D9A-4039-AEAD-F33A8ABF5048}"/>
            </c:ext>
          </c:extLst>
        </c:ser>
        <c:ser>
          <c:idx val="1"/>
          <c:order val="1"/>
          <c:tx>
            <c:strRef>
              <c:f>Hematologia!$A$10</c:f>
              <c:strCache>
                <c:ptCount val="1"/>
                <c:pt idx="0">
                  <c:v>FB-KO</c:v>
                </c:pt>
              </c:strCache>
            </c:strRef>
          </c:tx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ematologia!$Q$15</c:f>
                <c:numCache>
                  <c:formatCode>General</c:formatCode>
                  <c:ptCount val="1"/>
                  <c:pt idx="0">
                    <c:v>64.065071086617337</c:v>
                  </c:pt>
                </c:numCache>
              </c:numRef>
            </c:plus>
            <c:minus>
              <c:numRef>
                <c:f>Hematologia!$Q$15</c:f>
                <c:numCache>
                  <c:formatCode>General</c:formatCode>
                  <c:ptCount val="1"/>
                  <c:pt idx="0">
                    <c:v>64.065071086617337</c:v>
                  </c:pt>
                </c:numCache>
              </c:numRef>
            </c:minus>
            <c:spPr>
              <a:ln w="19050" cap="sq"/>
            </c:spPr>
          </c:errBars>
          <c:cat>
            <c:strRef>
              <c:f>Hematologia!$Q$3</c:f>
              <c:strCache>
                <c:ptCount val="1"/>
                <c:pt idx="0">
                  <c:v>PLT</c:v>
                </c:pt>
              </c:strCache>
            </c:strRef>
          </c:cat>
          <c:val>
            <c:numRef>
              <c:f>Hematologia!$Q$14</c:f>
              <c:numCache>
                <c:formatCode>0.00</c:formatCode>
                <c:ptCount val="1"/>
                <c:pt idx="0">
                  <c:v>612.3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D9A-4039-AEAD-F33A8ABF50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2642048"/>
        <c:axId val="82643584"/>
      </c:barChart>
      <c:catAx>
        <c:axId val="82642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 rot="0"/>
          <a:lstStyle/>
          <a:p>
            <a:pPr>
              <a:defRPr sz="1200" b="1">
                <a:solidFill>
                  <a:sysClr val="windowText" lastClr="000000"/>
                </a:solidFill>
              </a:defRPr>
            </a:pPr>
            <a:endParaRPr lang="en-US"/>
          </a:p>
        </c:txPr>
        <c:crossAx val="82643584"/>
        <c:crosses val="autoZero"/>
        <c:auto val="1"/>
        <c:lblAlgn val="ctr"/>
        <c:lblOffset val="100"/>
        <c:noMultiLvlLbl val="0"/>
      </c:catAx>
      <c:valAx>
        <c:axId val="826435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8264204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3462B4-9928-45E5-A9A7-F27AA725CA8E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F2545-CD74-4B24-B4D1-E27F023AA46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21744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08438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98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68141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13006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948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21174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1251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79904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7478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9665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92313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A9809-FC45-4A32-A121-E51B5FDDFB91}" type="datetimeFigureOut">
              <a:rPr lang="pl-PL" smtClean="0"/>
              <a:t>06.05.2019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4C2D2-AF39-4098-B6BE-53B53F171A8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666636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188590" y="6461658"/>
            <a:ext cx="3151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      </a:t>
            </a:r>
            <a:r>
              <a:rPr lang="pl-PL" b="1" dirty="0" smtClean="0"/>
              <a:t>Supplementa</a:t>
            </a:r>
            <a:r>
              <a:rPr lang="en-US" b="1" dirty="0" smtClean="0"/>
              <a:t>r</a:t>
            </a:r>
            <a:r>
              <a:rPr lang="pl-PL" b="1" dirty="0" smtClean="0"/>
              <a:t>y </a:t>
            </a:r>
            <a:r>
              <a:rPr lang="en-US" b="1" dirty="0"/>
              <a:t>Figure 1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17005" y="271193"/>
            <a:ext cx="6379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044882"/>
              </p:ext>
            </p:extLst>
          </p:nvPr>
        </p:nvGraphicFramePr>
        <p:xfrm>
          <a:off x="810558" y="128341"/>
          <a:ext cx="5038160" cy="27216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2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8085696"/>
              </p:ext>
            </p:extLst>
          </p:nvPr>
        </p:nvGraphicFramePr>
        <p:xfrm>
          <a:off x="954936" y="2992835"/>
          <a:ext cx="7555733" cy="27387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3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6945357"/>
              </p:ext>
            </p:extLst>
          </p:nvPr>
        </p:nvGraphicFramePr>
        <p:xfrm>
          <a:off x="5530863" y="27010"/>
          <a:ext cx="3151754" cy="2822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24086113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7</TotalTime>
  <Words>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93</cp:revision>
  <dcterms:created xsi:type="dcterms:W3CDTF">2019-01-18T11:33:21Z</dcterms:created>
  <dcterms:modified xsi:type="dcterms:W3CDTF">2019-05-06T15:08:17Z</dcterms:modified>
</cp:coreProperties>
</file>